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>
        <p:scale>
          <a:sx n="60" d="100"/>
          <a:sy n="60" d="100"/>
        </p:scale>
        <p:origin x="-2292" y="-7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B70EE-596C-4BED-9493-5E3424CCAC98}" type="datetimeFigureOut">
              <a:rPr lang="zh-CN" altLang="en-US" smtClean="0"/>
              <a:pPr/>
              <a:t>2016/6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D3EC3D-8D60-4CDC-B041-1FB34323E6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/>
          <p:cNvGrpSpPr/>
          <p:nvPr/>
        </p:nvGrpSpPr>
        <p:grpSpPr>
          <a:xfrm>
            <a:off x="-4706566" y="-18716780"/>
            <a:ext cx="17189079" cy="41913330"/>
            <a:chOff x="-4706566" y="-18716780"/>
            <a:chExt cx="17189079" cy="41913330"/>
          </a:xfrm>
        </p:grpSpPr>
        <p:pic>
          <p:nvPicPr>
            <p:cNvPr id="1030" name="Picture 6" descr="C:\Users\Administrator\Desktop\无标题.pn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-4252913" y="-17732375"/>
              <a:ext cx="16735426" cy="40928925"/>
            </a:xfrm>
            <a:prstGeom prst="rect">
              <a:avLst/>
            </a:prstGeom>
            <a:noFill/>
          </p:spPr>
        </p:pic>
        <p:grpSp>
          <p:nvGrpSpPr>
            <p:cNvPr id="32" name="组合 31"/>
            <p:cNvGrpSpPr/>
            <p:nvPr/>
          </p:nvGrpSpPr>
          <p:grpSpPr>
            <a:xfrm>
              <a:off x="-3643370" y="-18716780"/>
              <a:ext cx="15859236" cy="1444899"/>
              <a:chOff x="-3643370" y="-18716780"/>
              <a:chExt cx="15859236" cy="1444899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-2119032" y="-17779712"/>
                <a:ext cx="14334898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r>
                  <a:rPr lang="en-US" altLang="zh-CN" sz="2700" dirty="0" smtClean="0">
                    <a:latin typeface="Times New Roman" pitchFamily="18" charset="0"/>
                    <a:cs typeface="Times New Roman" pitchFamily="18" charset="0"/>
                  </a:rPr>
                  <a:t>   </a:t>
                </a:r>
                <a:r>
                  <a:rPr lang="en-US" altLang="zh-CN" sz="2700" u="sng" dirty="0" err="1" smtClean="0">
                    <a:latin typeface="Times New Roman" pitchFamily="18" charset="0"/>
                    <a:cs typeface="Times New Roman" pitchFamily="18" charset="0"/>
                  </a:rPr>
                  <a:t>gabcdef</a:t>
                </a:r>
                <a:endParaRPr lang="zh-CN" altLang="en-US" sz="2700" u="sng" dirty="0" smtClean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-2261908" y="-18216714"/>
                <a:ext cx="1369195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      L0          L1           L2            L3           L4           L5          L6          L7           L8           L9 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-3643370" y="-18716780"/>
                <a:ext cx="1550204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     ID                                                                 </a:t>
                </a:r>
                <a:r>
                  <a:rPr lang="en-US" altLang="zh-CN" sz="2800" dirty="0" err="1" smtClean="0">
                    <a:latin typeface="Times New Roman" pitchFamily="18" charset="0"/>
                    <a:cs typeface="Times New Roman" pitchFamily="18" charset="0"/>
                  </a:rPr>
                  <a:t>Leucine</a:t>
                </a:r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 Zipper Region  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-4706566" y="-15567094"/>
              <a:ext cx="1000132" cy="36941816"/>
              <a:chOff x="-4572064" y="-15567094"/>
              <a:chExt cx="1000132" cy="36941816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-4572064" y="-15567094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-4572064" y="-12691844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-4572064" y="-11524696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3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-4572064" y="-10064404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4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-4572064" y="-8048374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5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-4572064" y="-6293960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6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-4572064" y="-4809524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7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-4572064" y="-3301938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8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-4572064" y="-2174696"/>
                <a:ext cx="42862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9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-4572064" y="437964"/>
                <a:ext cx="64294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0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-4572064" y="3912322"/>
                <a:ext cx="71438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1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-4572064" y="6510194"/>
                <a:ext cx="57150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2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-4572064" y="8287766"/>
                <a:ext cx="92869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3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-4572064" y="10068810"/>
                <a:ext cx="100013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4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-4572064" y="11787250"/>
                <a:ext cx="78581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5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-4572064" y="13010070"/>
                <a:ext cx="78581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6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-4572064" y="14454596"/>
                <a:ext cx="78581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7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-4572064" y="15900104"/>
                <a:ext cx="64294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8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-4572064" y="17638756"/>
                <a:ext cx="78581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19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-4572064" y="20851502"/>
                <a:ext cx="64294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 smtClean="0">
                    <a:latin typeface="Times New Roman" pitchFamily="18" charset="0"/>
                    <a:cs typeface="Times New Roman" pitchFamily="18" charset="0"/>
                  </a:rPr>
                  <a:t>20</a:t>
                </a:r>
                <a:endParaRPr lang="zh-CN" altLang="en-US" sz="2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6</Words>
  <Application>Microsoft Office PowerPoint</Application>
  <PresentationFormat>全屏显示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CHIN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USER</cp:lastModifiedBy>
  <cp:revision>6</cp:revision>
  <dcterms:created xsi:type="dcterms:W3CDTF">2016-06-18T10:15:06Z</dcterms:created>
  <dcterms:modified xsi:type="dcterms:W3CDTF">2016-06-18T10:41:25Z</dcterms:modified>
</cp:coreProperties>
</file>